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handoutMasterIdLst>
    <p:handoutMasterId r:id="rId7"/>
  </p:handoutMasterIdLst>
  <p:sldIdLst>
    <p:sldId id="329" r:id="rId2"/>
    <p:sldId id="330" r:id="rId3"/>
    <p:sldId id="268" r:id="rId4"/>
    <p:sldId id="331" r:id="rId5"/>
  </p:sldIdLst>
  <p:sldSz cx="7772400" cy="100584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Alber, Gottfried" initials="AG" lastIdx="3" clrIdx="6">
    <p:extLst>
      <p:ext uri="{19B8F6BF-5375-455C-9EA6-DF929625EA0E}">
        <p15:presenceInfo xmlns:p15="http://schemas.microsoft.com/office/powerpoint/2012/main" userId="S-1-5-21-2361800232-213331468-3115616407-43116" providerId="AD"/>
      </p:ext>
    </p:extLst>
  </p:cmAuthor>
  <p:cmAuthor id="1" name="Eschke, Maria" initials="EM" lastIdx="8" clrIdx="0">
    <p:extLst>
      <p:ext uri="{19B8F6BF-5375-455C-9EA6-DF929625EA0E}">
        <p15:presenceInfo xmlns:p15="http://schemas.microsoft.com/office/powerpoint/2012/main" userId="Eschke, Maria" providerId="None"/>
      </p:ext>
    </p:extLst>
  </p:cmAuthor>
  <p:cmAuthor id="2" name="Maria Eschke" initials="ME [2]" lastIdx="32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Maria Eschke" initials="ME" lastIdx="3" clrIdx="2">
    <p:extLst>
      <p:ext uri="{19B8F6BF-5375-455C-9EA6-DF929625EA0E}">
        <p15:presenceInfo xmlns:p15="http://schemas.microsoft.com/office/powerpoint/2012/main" userId="3990a6e585f05a8f" providerId="Windows Live"/>
      </p:ext>
    </p:extLst>
  </p:cmAuthor>
  <p:cmAuthor id="4" name="Eschke, Maria" initials="EM [2]" lastIdx="63" clrIdx="3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5" name="Haiyang Chang" initials="HC" lastIdx="7" clrIdx="4">
    <p:extLst>
      <p:ext uri="{19B8F6BF-5375-455C-9EA6-DF929625EA0E}">
        <p15:presenceInfo xmlns:p15="http://schemas.microsoft.com/office/powerpoint/2012/main" userId="S::hchang02@uoguelph.ca::885c416c-8d8f-4213-aa0a-bfd7a90b49d5" providerId="AD"/>
      </p:ext>
    </p:extLst>
  </p:cmAuthor>
  <p:cmAuthor id="6" name="Stefan Keller" initials="SK" lastIdx="9" clrIdx="5">
    <p:extLst>
      <p:ext uri="{19B8F6BF-5375-455C-9EA6-DF929625EA0E}">
        <p15:presenceInfo xmlns:p15="http://schemas.microsoft.com/office/powerpoint/2012/main" userId="Stefan Ke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E61B1D"/>
    <a:srgbClr val="6D409B"/>
    <a:srgbClr val="FB9A9A"/>
    <a:srgbClr val="2DCDCF"/>
    <a:srgbClr val="FF5451"/>
    <a:srgbClr val="7BA073"/>
    <a:srgbClr val="739B6B"/>
    <a:srgbClr val="D40000"/>
    <a:srgbClr val="7092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27" autoAdjust="0"/>
    <p:restoredTop sz="86518" autoAdjust="0"/>
  </p:normalViewPr>
  <p:slideViewPr>
    <p:cSldViewPr snapToGrid="0" snapToObjects="1">
      <p:cViewPr>
        <p:scale>
          <a:sx n="100" d="100"/>
          <a:sy n="100" d="100"/>
        </p:scale>
        <p:origin x="1704" y="-98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7C08A1E7-65B8-46C4-995A-7A25B2332B4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3C643E0-CAF5-48CD-B065-DECDB40DF8A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689" y="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AB8EDB35-49D5-4589-9391-C9210A9F6307}" type="datetimeFigureOut">
              <a:rPr lang="de-DE" smtClean="0"/>
              <a:t>19.04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60E1D74-5813-40CA-805B-B51014FC0D8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788BD1A-CDB6-44F3-B6AD-50907CEEB50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689" y="9429750"/>
            <a:ext cx="2946400" cy="496888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176C8060-2553-4E13-86A2-DC575B055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709784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32" tIns="45716" rIns="91432" bIns="45716" rtlCol="0"/>
          <a:lstStyle>
            <a:lvl1pPr algn="r">
              <a:defRPr sz="1200"/>
            </a:lvl1pPr>
          </a:lstStyle>
          <a:p>
            <a:fld id="{F3196B2A-A5DF-E64D-90A1-AF8995343E41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241425"/>
            <a:ext cx="2587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2" tIns="45716" rIns="91432" bIns="4571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32" tIns="45716" rIns="91432" bIns="45716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5"/>
            <a:ext cx="2945659" cy="49805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4" y="9428585"/>
            <a:ext cx="2945659" cy="498055"/>
          </a:xfrm>
          <a:prstGeom prst="rect">
            <a:avLst/>
          </a:prstGeom>
        </p:spPr>
        <p:txBody>
          <a:bodyPr vert="horz" lIns="91432" tIns="45716" rIns="91432" bIns="45716" rtlCol="0" anchor="b"/>
          <a:lstStyle>
            <a:lvl1pPr algn="r">
              <a:defRPr sz="1200"/>
            </a:lvl1pPr>
          </a:lstStyle>
          <a:p>
            <a:fld id="{A8486DBC-F850-AF4E-A4F7-589B89B56F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2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486DBC-F850-AF4E-A4F7-589B89B56F4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9414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486DBC-F850-AF4E-A4F7-589B89B56F4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3809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486DBC-F850-AF4E-A4F7-589B89B56F4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523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20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97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67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2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20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74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839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960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0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E7CD-CBC8-F146-8407-13C1930F219E}" type="datetimeFigureOut">
              <a:rPr lang="en-US" smtClean="0"/>
              <a:t>4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19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11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12" Type="http://schemas.openxmlformats.org/officeDocument/2006/relationships/image" Target="../media/image10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11" Type="http://schemas.openxmlformats.org/officeDocument/2006/relationships/image" Target="../media/image9.tif"/><Relationship Id="rId5" Type="http://schemas.openxmlformats.org/officeDocument/2006/relationships/image" Target="../media/image3.tif"/><Relationship Id="rId10" Type="http://schemas.openxmlformats.org/officeDocument/2006/relationships/image" Target="../media/image8.tif"/><Relationship Id="rId4" Type="http://schemas.openxmlformats.org/officeDocument/2006/relationships/image" Target="../media/image2.tif"/><Relationship Id="rId9" Type="http://schemas.openxmlformats.org/officeDocument/2006/relationships/image" Target="../media/image7.tif"/><Relationship Id="rId14" Type="http://schemas.openxmlformats.org/officeDocument/2006/relationships/image" Target="../media/image1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tif"/><Relationship Id="rId5" Type="http://schemas.openxmlformats.org/officeDocument/2006/relationships/image" Target="../media/image15.tif"/><Relationship Id="rId4" Type="http://schemas.openxmlformats.org/officeDocument/2006/relationships/image" Target="../media/image14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3" Type="http://schemas.openxmlformats.org/officeDocument/2006/relationships/image" Target="../media/image17.tif"/><Relationship Id="rId7" Type="http://schemas.openxmlformats.org/officeDocument/2006/relationships/image" Target="../media/image21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"/><Relationship Id="rId5" Type="http://schemas.openxmlformats.org/officeDocument/2006/relationships/image" Target="../media/image19.tif"/><Relationship Id="rId4" Type="http://schemas.openxmlformats.org/officeDocument/2006/relationships/image" Target="../media/image18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"/><Relationship Id="rId2" Type="http://schemas.openxmlformats.org/officeDocument/2006/relationships/image" Target="../media/image2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tif"/><Relationship Id="rId5" Type="http://schemas.openxmlformats.org/officeDocument/2006/relationships/image" Target="../media/image26.tif"/><Relationship Id="rId4" Type="http://schemas.openxmlformats.org/officeDocument/2006/relationships/image" Target="../media/image2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735"/>
          <a:stretch/>
        </p:blipFill>
        <p:spPr>
          <a:xfrm>
            <a:off x="3887243" y="3565695"/>
            <a:ext cx="2169414" cy="1662409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41"/>
          <a:stretch/>
        </p:blipFill>
        <p:spPr>
          <a:xfrm>
            <a:off x="3915378" y="1529842"/>
            <a:ext cx="2121408" cy="1684913"/>
          </a:xfrm>
          <a:prstGeom prst="rect">
            <a:avLst/>
          </a:prstGeom>
        </p:spPr>
      </p:pic>
      <p:sp>
        <p:nvSpPr>
          <p:cNvPr id="39" name="Rechteck 38"/>
          <p:cNvSpPr/>
          <p:nvPr/>
        </p:nvSpPr>
        <p:spPr>
          <a:xfrm>
            <a:off x="-6720" y="3179148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1677992" y="929734"/>
            <a:ext cx="7328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 vivo</a:t>
            </a:r>
            <a:endParaRPr lang="en-GB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103485" y="929734"/>
            <a:ext cx="134095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o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mulation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-6720" y="1217558"/>
            <a:ext cx="397866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-6720" y="513064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3629269" y="3179148"/>
            <a:ext cx="3818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3629269" y="1217558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3629269" y="5130642"/>
            <a:ext cx="40748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4" name="Gruppieren 63"/>
          <p:cNvGrpSpPr/>
          <p:nvPr/>
        </p:nvGrpSpPr>
        <p:grpSpPr>
          <a:xfrm>
            <a:off x="6887624" y="835093"/>
            <a:ext cx="870751" cy="466281"/>
            <a:chOff x="5397565" y="836811"/>
            <a:chExt cx="870751" cy="466281"/>
          </a:xfrm>
        </p:grpSpPr>
        <p:sp>
          <p:nvSpPr>
            <p:cNvPr id="65" name="Textfeld 64"/>
            <p:cNvSpPr txBox="1"/>
            <p:nvPr/>
          </p:nvSpPr>
          <p:spPr>
            <a:xfrm>
              <a:off x="5397565" y="836811"/>
              <a:ext cx="870751" cy="46628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lang="de-DE" sz="900" dirty="0"/>
                <a:t>M:  Medium</a:t>
              </a:r>
            </a:p>
            <a:p>
              <a:pPr>
                <a:lnSpc>
                  <a:spcPct val="90000"/>
                </a:lnSpc>
              </a:pPr>
              <a:r>
                <a:rPr lang="de-DE" sz="900" dirty="0"/>
                <a:t>P/I: PMA/</a:t>
              </a:r>
            </a:p>
            <a:p>
              <a:pPr>
                <a:lnSpc>
                  <a:spcPct val="90000"/>
                </a:lnSpc>
              </a:pPr>
              <a:r>
                <a:rPr lang="de-DE" sz="600" dirty="0">
                  <a:solidFill>
                    <a:prstClr val="black"/>
                  </a:solidFill>
                </a:rPr>
                <a:t>           </a:t>
              </a:r>
              <a:r>
                <a:rPr lang="de-DE" sz="900" dirty="0" err="1">
                  <a:solidFill>
                    <a:prstClr val="black"/>
                  </a:solidFill>
                </a:rPr>
                <a:t>ionomycin</a:t>
              </a:r>
              <a:endParaRPr lang="de-DE" sz="900" dirty="0">
                <a:solidFill>
                  <a:prstClr val="black"/>
                </a:solidFill>
              </a:endParaRPr>
            </a:p>
          </p:txBody>
        </p:sp>
        <p:sp>
          <p:nvSpPr>
            <p:cNvPr id="66" name="Rechteck 65"/>
            <p:cNvSpPr/>
            <p:nvPr/>
          </p:nvSpPr>
          <p:spPr>
            <a:xfrm>
              <a:off x="5474829" y="878331"/>
              <a:ext cx="705504" cy="37300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30" name="Rechteck 29"/>
          <p:cNvSpPr/>
          <p:nvPr/>
        </p:nvSpPr>
        <p:spPr>
          <a:xfrm>
            <a:off x="1084792" y="1338387"/>
            <a:ext cx="4411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2638338" y="1338387"/>
            <a:ext cx="5261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D8A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4811949" y="1338387"/>
            <a:ext cx="4411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6526970" y="1338387"/>
            <a:ext cx="5261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D8A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811480" y="3261884"/>
            <a:ext cx="98777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2RA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CD25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2638338" y="3261884"/>
            <a:ext cx="5261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D8B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4538637" y="3261884"/>
            <a:ext cx="98777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2RA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CD25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6526970" y="3261884"/>
            <a:ext cx="5261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D8B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701674" y="5218386"/>
            <a:ext cx="12073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ZBTB7B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POK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2591851" y="5218386"/>
            <a:ext cx="61908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RUNX3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4428831" y="5218386"/>
            <a:ext cx="12073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ZBTB7B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POK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6480483" y="5218386"/>
            <a:ext cx="61908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RUNX3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66"/>
          <a:stretch/>
        </p:blipFill>
        <p:spPr>
          <a:xfrm>
            <a:off x="365390" y="1624942"/>
            <a:ext cx="1456182" cy="1660748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5" t="12822" b="-4540"/>
          <a:stretch/>
        </p:blipFill>
        <p:spPr>
          <a:xfrm>
            <a:off x="2260342" y="1619044"/>
            <a:ext cx="1154452" cy="1731849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83" t="11311"/>
          <a:stretch/>
        </p:blipFill>
        <p:spPr>
          <a:xfrm>
            <a:off x="2262291" y="3523490"/>
            <a:ext cx="1150555" cy="1660460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20"/>
          <a:stretch/>
        </p:blipFill>
        <p:spPr>
          <a:xfrm>
            <a:off x="392822" y="3564141"/>
            <a:ext cx="1401318" cy="1639953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12" t="11705"/>
          <a:stretch/>
        </p:blipFill>
        <p:spPr>
          <a:xfrm>
            <a:off x="2283312" y="5527880"/>
            <a:ext cx="1108512" cy="1642996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51"/>
          <a:stretch/>
        </p:blipFill>
        <p:spPr>
          <a:xfrm>
            <a:off x="382535" y="5547343"/>
            <a:ext cx="1421892" cy="1623533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48" t="11325"/>
          <a:stretch/>
        </p:blipFill>
        <p:spPr>
          <a:xfrm>
            <a:off x="5889605" y="1529842"/>
            <a:ext cx="1876425" cy="1696693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57" t="11754"/>
          <a:stretch/>
        </p:blipFill>
        <p:spPr>
          <a:xfrm>
            <a:off x="5876966" y="3539617"/>
            <a:ext cx="1884726" cy="1688487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70"/>
          <a:stretch/>
        </p:blipFill>
        <p:spPr>
          <a:xfrm>
            <a:off x="3887243" y="5556265"/>
            <a:ext cx="2146554" cy="1670951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89" t="11588"/>
          <a:stretch/>
        </p:blipFill>
        <p:spPr>
          <a:xfrm>
            <a:off x="5896944" y="5527880"/>
            <a:ext cx="1858592" cy="1691659"/>
          </a:xfrm>
          <a:prstGeom prst="rect">
            <a:avLst/>
          </a:prstGeom>
        </p:spPr>
      </p:pic>
      <p:sp>
        <p:nvSpPr>
          <p:cNvPr id="37" name="Rechteck 36"/>
          <p:cNvSpPr/>
          <p:nvPr/>
        </p:nvSpPr>
        <p:spPr>
          <a:xfrm>
            <a:off x="-6720" y="443613"/>
            <a:ext cx="397866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682092" y="487670"/>
            <a:ext cx="2385395" cy="23842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190537" y="468384"/>
            <a:ext cx="3368505" cy="27699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1200" b="1" i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de-DE" i="0" dirty="0" err="1" smtClean="0"/>
              <a:t>Gating</a:t>
            </a:r>
            <a:r>
              <a:rPr lang="de-DE" i="0" dirty="0" smtClean="0"/>
              <a:t> </a:t>
            </a:r>
            <a:r>
              <a:rPr lang="de-DE" i="0" dirty="0" err="1"/>
              <a:t>strategy</a:t>
            </a:r>
            <a:r>
              <a:rPr lang="de-DE" i="0" dirty="0"/>
              <a:t> </a:t>
            </a:r>
            <a:r>
              <a:rPr lang="de-DE" i="0" dirty="0" err="1"/>
              <a:t>as</a:t>
            </a:r>
            <a:r>
              <a:rPr lang="de-DE" i="0" dirty="0"/>
              <a:t> </a:t>
            </a:r>
            <a:r>
              <a:rPr lang="de-DE" i="0" dirty="0" err="1"/>
              <a:t>shown</a:t>
            </a:r>
            <a:r>
              <a:rPr lang="de-DE" i="0" dirty="0"/>
              <a:t> in Fig. 1A</a:t>
            </a:r>
          </a:p>
        </p:txBody>
      </p:sp>
      <p:sp>
        <p:nvSpPr>
          <p:cNvPr id="8" name="Rechteck 7"/>
          <p:cNvSpPr/>
          <p:nvPr/>
        </p:nvSpPr>
        <p:spPr>
          <a:xfrm>
            <a:off x="89457" y="7334710"/>
            <a:ext cx="7580935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: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ation of g</a:t>
            </a:r>
            <a:r>
              <a:rPr lang="en-US" sz="12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e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</a:t>
            </a:r>
            <a:r>
              <a:rPr lang="en-US" sz="1200" b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200" b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rted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ine peripheral conventional and non-conventional TCRαβ</a:t>
            </a:r>
            <a:r>
              <a:rPr lang="en-US" sz="1200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populations to succinate dehydrogenase subunit A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SDHA), a referenc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of a different functional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ss than beta-2-macroglobulin (B2M), yields comparable result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ompare Fig. 1B-G)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A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ing strategy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isolation of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D4/CD8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CR</a:t>
            </a:r>
            <a:r>
              <a:rPr lang="de-D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β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populations as shown in Fig 1A.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-G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ingle-positive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, CD8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l-GR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8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ouble-positive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CD4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8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ouble-negative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T cell subpopulations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zed by RT-qPCR. Expression of indicated genes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 vivo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-D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after 5 h of medium (M) incubation or stimulation with PMA/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onomyci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/I)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-G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Each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t represents one individual dog analyzed separately in independent experiments (n=4 or 5). Depending on normal distribution, data sets are presented with the mean or median (horizontal bars). Statistical differences between subpopulations are marked with lines. Additionally, in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-G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significance of stimulation-induced effects was calculated for each subpopulation by direct comparison of M versus the P/I equivalent (colored asterisks without lines). (* p &lt; 0.05; ** p &lt; 0.01; *** p &lt; 0.001; **** p &lt; 0.0001). Blue asterisks in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icate significantly increased expression of CD8A in the purified CD8A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 compared to all other populations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DHA: succinate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dehydrogenase subunit A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ference gene for normalization).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83210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291"/>
          <a:stretch/>
        </p:blipFill>
        <p:spPr>
          <a:xfrm>
            <a:off x="3725378" y="2933699"/>
            <a:ext cx="2169414" cy="165907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34"/>
          <a:stretch/>
        </p:blipFill>
        <p:spPr>
          <a:xfrm>
            <a:off x="3689096" y="981075"/>
            <a:ext cx="2221992" cy="1698314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816939" y="548259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3513843" y="2663481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3513843" y="548259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1816939" y="2663481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5504301" y="600413"/>
            <a:ext cx="780983" cy="424732"/>
            <a:chOff x="4324236" y="926627"/>
            <a:chExt cx="780983" cy="424732"/>
          </a:xfrm>
        </p:grpSpPr>
        <p:sp>
          <p:nvSpPr>
            <p:cNvPr id="37" name="Textfeld 36"/>
            <p:cNvSpPr txBox="1"/>
            <p:nvPr/>
          </p:nvSpPr>
          <p:spPr>
            <a:xfrm>
              <a:off x="4324236" y="926627"/>
              <a:ext cx="780983" cy="4247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lang="de-DE" sz="800" dirty="0"/>
                <a:t>M:  Medium</a:t>
              </a:r>
            </a:p>
            <a:p>
              <a:pPr>
                <a:lnSpc>
                  <a:spcPct val="90000"/>
                </a:lnSpc>
              </a:pPr>
              <a:r>
                <a:rPr lang="de-DE" sz="800" dirty="0"/>
                <a:t>P/I: PMA/</a:t>
              </a:r>
            </a:p>
            <a:p>
              <a:pPr>
                <a:lnSpc>
                  <a:spcPct val="90000"/>
                </a:lnSpc>
              </a:pPr>
              <a:r>
                <a:rPr lang="de-DE" sz="500" dirty="0">
                  <a:solidFill>
                    <a:prstClr val="black"/>
                  </a:solidFill>
                </a:rPr>
                <a:t>           </a:t>
              </a:r>
              <a:r>
                <a:rPr lang="de-DE" sz="800" dirty="0" err="1">
                  <a:solidFill>
                    <a:prstClr val="black"/>
                  </a:solidFill>
                </a:rPr>
                <a:t>ionomycin</a:t>
              </a:r>
              <a:endParaRPr lang="de-DE" sz="800" dirty="0">
                <a:solidFill>
                  <a:prstClr val="black"/>
                </a:solidFill>
              </a:endParaRPr>
            </a:p>
          </p:txBody>
        </p:sp>
        <p:sp>
          <p:nvSpPr>
            <p:cNvPr id="39" name="Rechteck 38"/>
            <p:cNvSpPr/>
            <p:nvPr/>
          </p:nvSpPr>
          <p:spPr>
            <a:xfrm>
              <a:off x="4401500" y="968148"/>
              <a:ext cx="629288" cy="332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8" name="Rechteck 17"/>
          <p:cNvSpPr/>
          <p:nvPr/>
        </p:nvSpPr>
        <p:spPr>
          <a:xfrm>
            <a:off x="2432156" y="673904"/>
            <a:ext cx="994182" cy="3539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TBX21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T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e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r>
              <a:rPr lang="de-DE" sz="700" i="1" dirty="0"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689115" y="673904"/>
            <a:ext cx="4908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FNG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2640935" y="2723352"/>
            <a:ext cx="562975" cy="3539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RORC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700" i="1" dirty="0"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677743" y="2723352"/>
            <a:ext cx="5164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17A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41"/>
          <a:stretch/>
        </p:blipFill>
        <p:spPr>
          <a:xfrm>
            <a:off x="2084711" y="1047713"/>
            <a:ext cx="1383030" cy="162726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022"/>
          <a:stretch/>
        </p:blipFill>
        <p:spPr>
          <a:xfrm>
            <a:off x="1926977" y="3078006"/>
            <a:ext cx="1540764" cy="1619940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89457" y="4945001"/>
            <a:ext cx="7580935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: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ation of g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e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ccinate dehydrogenase subunit A (SDHA), a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ferenc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of a different functional class than beta-2-macroglobulin (B2M), yields comparable results </a:t>
            </a: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garding T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elper (</a:t>
            </a:r>
            <a:r>
              <a:rPr lang="en-GB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1 and Th17 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properties of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ine conventional and non-conventional TCRαβ</a:t>
            </a:r>
            <a:r>
              <a:rPr lang="en-US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 subpopulations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e Fig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)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D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rted TC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αβ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 cell subpopulations, as shown in Fig. 1A, were analyzed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expression of indicated genes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 vivo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, B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after 5 h of medium (M) incubation or stimulation with PMA/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onomyci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/I)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, D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ingle-positiv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double-positiv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double-negative)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ch dot represents one individual dog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zed separately in independent experiments (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4 or 5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D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pending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n normal distribution, data sets are presented with the mean or median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differences between subpopulations are marked with lines. Additionally, in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, D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significance of stimulation-induced effects was calculated for each subpopulation by direct comparison of M versus the P/I equivalent (colored asterisks without lines)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*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.05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 p &lt;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.001).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7767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eck 9"/>
          <p:cNvSpPr/>
          <p:nvPr/>
        </p:nvSpPr>
        <p:spPr>
          <a:xfrm>
            <a:off x="1490769" y="529400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D0646A8E-FBB6-49D8-A68A-1BDFF3FBF0CF}"/>
              </a:ext>
            </a:extLst>
          </p:cNvPr>
          <p:cNvSpPr/>
          <p:nvPr/>
        </p:nvSpPr>
        <p:spPr>
          <a:xfrm>
            <a:off x="-37905" y="532404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Rechteck 23">
            <a:extLst>
              <a:ext uri="{FF2B5EF4-FFF2-40B4-BE49-F238E27FC236}">
                <a16:creationId xmlns:a16="http://schemas.microsoft.com/office/drawing/2014/main" id="{B6ECD26D-B951-46A0-B86C-8F8F3DDC3D78}"/>
              </a:ext>
            </a:extLst>
          </p:cNvPr>
          <p:cNvSpPr/>
          <p:nvPr/>
        </p:nvSpPr>
        <p:spPr>
          <a:xfrm>
            <a:off x="-37905" y="2639201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Gruppieren 25"/>
          <p:cNvGrpSpPr/>
          <p:nvPr/>
        </p:nvGrpSpPr>
        <p:grpSpPr>
          <a:xfrm>
            <a:off x="3723587" y="2773288"/>
            <a:ext cx="780983" cy="424732"/>
            <a:chOff x="4324236" y="926627"/>
            <a:chExt cx="780983" cy="424732"/>
          </a:xfrm>
        </p:grpSpPr>
        <p:sp>
          <p:nvSpPr>
            <p:cNvPr id="27" name="Textfeld 26"/>
            <p:cNvSpPr txBox="1"/>
            <p:nvPr/>
          </p:nvSpPr>
          <p:spPr>
            <a:xfrm>
              <a:off x="4324236" y="926627"/>
              <a:ext cx="780983" cy="4247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lang="de-DE" sz="800" dirty="0"/>
                <a:t>M:  Medium</a:t>
              </a:r>
            </a:p>
            <a:p>
              <a:pPr>
                <a:lnSpc>
                  <a:spcPct val="90000"/>
                </a:lnSpc>
              </a:pPr>
              <a:r>
                <a:rPr lang="de-DE" sz="800" dirty="0"/>
                <a:t>P/I: PMA/</a:t>
              </a:r>
            </a:p>
            <a:p>
              <a:pPr>
                <a:lnSpc>
                  <a:spcPct val="90000"/>
                </a:lnSpc>
              </a:pPr>
              <a:r>
                <a:rPr lang="de-DE" sz="500" dirty="0">
                  <a:solidFill>
                    <a:prstClr val="black"/>
                  </a:solidFill>
                </a:rPr>
                <a:t>           </a:t>
              </a:r>
              <a:r>
                <a:rPr lang="de-DE" sz="800" dirty="0" err="1">
                  <a:solidFill>
                    <a:prstClr val="black"/>
                  </a:solidFill>
                </a:rPr>
                <a:t>ionomycin</a:t>
              </a:r>
              <a:endParaRPr lang="de-DE" sz="800" dirty="0">
                <a:solidFill>
                  <a:prstClr val="black"/>
                </a:solidFill>
              </a:endParaRPr>
            </a:p>
          </p:txBody>
        </p:sp>
        <p:sp>
          <p:nvSpPr>
            <p:cNvPr id="28" name="Rechteck 27"/>
            <p:cNvSpPr/>
            <p:nvPr/>
          </p:nvSpPr>
          <p:spPr>
            <a:xfrm>
              <a:off x="4401500" y="968148"/>
              <a:ext cx="629288" cy="332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6988482" y="714356"/>
            <a:ext cx="780983" cy="424732"/>
            <a:chOff x="4324236" y="926627"/>
            <a:chExt cx="780983" cy="424732"/>
          </a:xfrm>
        </p:grpSpPr>
        <p:sp>
          <p:nvSpPr>
            <p:cNvPr id="30" name="Textfeld 29"/>
            <p:cNvSpPr txBox="1"/>
            <p:nvPr/>
          </p:nvSpPr>
          <p:spPr>
            <a:xfrm>
              <a:off x="4324236" y="926627"/>
              <a:ext cx="780983" cy="4247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lang="de-DE" sz="800" dirty="0"/>
                <a:t>M:  Medium</a:t>
              </a:r>
            </a:p>
            <a:p>
              <a:pPr>
                <a:lnSpc>
                  <a:spcPct val="90000"/>
                </a:lnSpc>
              </a:pPr>
              <a:r>
                <a:rPr lang="de-DE" sz="800" dirty="0"/>
                <a:t>P/I: PMA/</a:t>
              </a:r>
            </a:p>
            <a:p>
              <a:pPr>
                <a:lnSpc>
                  <a:spcPct val="90000"/>
                </a:lnSpc>
              </a:pPr>
              <a:r>
                <a:rPr lang="de-DE" sz="500" dirty="0">
                  <a:solidFill>
                    <a:prstClr val="black"/>
                  </a:solidFill>
                </a:rPr>
                <a:t>           </a:t>
              </a:r>
              <a:r>
                <a:rPr lang="de-DE" sz="800" dirty="0" err="1">
                  <a:solidFill>
                    <a:prstClr val="black"/>
                  </a:solidFill>
                </a:rPr>
                <a:t>ionomycin</a:t>
              </a:r>
              <a:endParaRPr lang="de-DE" sz="800" dirty="0">
                <a:solidFill>
                  <a:prstClr val="black"/>
                </a:solidFill>
              </a:endParaRPr>
            </a:p>
          </p:txBody>
        </p:sp>
        <p:sp>
          <p:nvSpPr>
            <p:cNvPr id="31" name="Rechteck 30"/>
            <p:cNvSpPr/>
            <p:nvPr/>
          </p:nvSpPr>
          <p:spPr>
            <a:xfrm>
              <a:off x="4401500" y="968148"/>
              <a:ext cx="629288" cy="332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33" name="Rechteck 32"/>
          <p:cNvSpPr/>
          <p:nvPr/>
        </p:nvSpPr>
        <p:spPr>
          <a:xfrm>
            <a:off x="1693969" y="2639201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787295" y="641354"/>
            <a:ext cx="603050" cy="3539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GATA3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700" i="1" dirty="0"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2636594" y="641354"/>
            <a:ext cx="3609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4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452484" y="641354"/>
            <a:ext cx="36099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5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6169183" y="641354"/>
            <a:ext cx="4315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13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498599" y="2707210"/>
            <a:ext cx="1167307" cy="3539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1RL1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IL-33R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700" i="1" dirty="0"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2558500" y="2707210"/>
            <a:ext cx="11673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1RL1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(IL-33R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de-DE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26"/>
          <a:stretch/>
        </p:blipFill>
        <p:spPr>
          <a:xfrm>
            <a:off x="238549" y="994009"/>
            <a:ext cx="1353312" cy="162944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41"/>
          <a:stretch/>
        </p:blipFill>
        <p:spPr>
          <a:xfrm>
            <a:off x="137965" y="3064670"/>
            <a:ext cx="1453896" cy="1648171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405"/>
          <a:stretch/>
        </p:blipFill>
        <p:spPr>
          <a:xfrm>
            <a:off x="1898024" y="3043788"/>
            <a:ext cx="2199132" cy="1676019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40"/>
          <a:stretch/>
        </p:blipFill>
        <p:spPr>
          <a:xfrm>
            <a:off x="1679443" y="972065"/>
            <a:ext cx="2121408" cy="165431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59" t="11661"/>
          <a:stretch/>
        </p:blipFill>
        <p:spPr>
          <a:xfrm>
            <a:off x="3656118" y="895059"/>
            <a:ext cx="1953728" cy="1690269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87" t="13653"/>
          <a:stretch/>
        </p:blipFill>
        <p:spPr>
          <a:xfrm>
            <a:off x="5438662" y="921885"/>
            <a:ext cx="1892573" cy="1652146"/>
          </a:xfrm>
          <a:prstGeom prst="rect">
            <a:avLst/>
          </a:prstGeom>
        </p:spPr>
      </p:pic>
      <p:sp>
        <p:nvSpPr>
          <p:cNvPr id="37" name="Rechteck 36"/>
          <p:cNvSpPr/>
          <p:nvPr/>
        </p:nvSpPr>
        <p:spPr>
          <a:xfrm>
            <a:off x="137966" y="5050245"/>
            <a:ext cx="7532426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3: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ation of g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e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to succinate dehydrogenase subunit A (SDHA), a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ferenc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of a different functional class than beta-2-macroglobulin (B2M), yields comparable results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garding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ype 2 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properties of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in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ventional and non-conventional TCRαβ</a:t>
            </a:r>
            <a:r>
              <a:rPr lang="en-US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 subpopulations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ompare Fig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)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(A-C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CR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αβ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 cell subpopulations sorted as shown in Fig. 1A were analyzed for expression of indicated type 2 immune response-related genes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 vivo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A, C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/or after 5 h of medium (M) incubation or stimulation with PMA/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ionomycin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P/I)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, D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single-positiv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double-positiv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d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: double-negative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ach dot represents one individual dog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nalyzed separately in independent experiments (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n=4 or 5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. D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pending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n normal distribution, data sets are presented with the mean or median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tatistical differences between subpopulations are marked with lines. Additionally, in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(B, D)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tatistical significance of stimulation-induced effects was calculated for each subpopulation by direct comparison of M versus the P/I equivalent using the Mann-Whitney test (colored asterisks without lines). (* p &lt; 0.05; ** p &lt; 0.01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.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977860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51"/>
          <a:stretch/>
        </p:blipFill>
        <p:spPr>
          <a:xfrm>
            <a:off x="3168067" y="2819567"/>
            <a:ext cx="2121408" cy="169044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74"/>
          <a:stretch/>
        </p:blipFill>
        <p:spPr>
          <a:xfrm>
            <a:off x="855095" y="2854447"/>
            <a:ext cx="2235708" cy="1655565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429"/>
          <a:stretch/>
        </p:blipFill>
        <p:spPr>
          <a:xfrm>
            <a:off x="4334262" y="762726"/>
            <a:ext cx="1453896" cy="165636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89"/>
          <a:stretch/>
        </p:blipFill>
        <p:spPr>
          <a:xfrm>
            <a:off x="2688260" y="800289"/>
            <a:ext cx="1321308" cy="1618107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35"/>
          <a:stretch/>
        </p:blipFill>
        <p:spPr>
          <a:xfrm>
            <a:off x="971011" y="772251"/>
            <a:ext cx="1383030" cy="1633346"/>
          </a:xfrm>
          <a:prstGeom prst="rect">
            <a:avLst/>
          </a:prstGeom>
        </p:spPr>
      </p:pic>
      <p:sp>
        <p:nvSpPr>
          <p:cNvPr id="8" name="Rechteck 7">
            <a:extLst>
              <a:ext uri="{FF2B5EF4-FFF2-40B4-BE49-F238E27FC236}">
                <a16:creationId xmlns:a16="http://schemas.microsoft.com/office/drawing/2014/main" id="{F8B6C290-41E4-4100-B36F-A193AEB82CF7}"/>
              </a:ext>
            </a:extLst>
          </p:cNvPr>
          <p:cNvSpPr/>
          <p:nvPr/>
        </p:nvSpPr>
        <p:spPr>
          <a:xfrm>
            <a:off x="821237" y="284395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836E0035-2960-4855-B17B-A53E1B8E5D07}"/>
              </a:ext>
            </a:extLst>
          </p:cNvPr>
          <p:cNvSpPr/>
          <p:nvPr/>
        </p:nvSpPr>
        <p:spPr>
          <a:xfrm>
            <a:off x="2501181" y="284395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FC35E01F-EE7A-4278-9362-156CDE959FB4}"/>
              </a:ext>
            </a:extLst>
          </p:cNvPr>
          <p:cNvSpPr/>
          <p:nvPr/>
        </p:nvSpPr>
        <p:spPr>
          <a:xfrm>
            <a:off x="4181125" y="284395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hteck 11">
            <a:extLst>
              <a:ext uri="{FF2B5EF4-FFF2-40B4-BE49-F238E27FC236}">
                <a16:creationId xmlns:a16="http://schemas.microsoft.com/office/drawing/2014/main" id="{FC35E01F-EE7A-4278-9362-156CDE959FB4}"/>
              </a:ext>
            </a:extLst>
          </p:cNvPr>
          <p:cNvSpPr/>
          <p:nvPr/>
        </p:nvSpPr>
        <p:spPr>
          <a:xfrm>
            <a:off x="821237" y="2480482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FC35E01F-EE7A-4278-9362-156CDE959FB4}"/>
              </a:ext>
            </a:extLst>
          </p:cNvPr>
          <p:cNvSpPr/>
          <p:nvPr/>
        </p:nvSpPr>
        <p:spPr>
          <a:xfrm>
            <a:off x="2936986" y="2480482"/>
            <a:ext cx="500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Gruppieren 19"/>
          <p:cNvGrpSpPr/>
          <p:nvPr/>
        </p:nvGrpSpPr>
        <p:grpSpPr>
          <a:xfrm>
            <a:off x="4975912" y="2528449"/>
            <a:ext cx="780983" cy="424732"/>
            <a:chOff x="4324236" y="926627"/>
            <a:chExt cx="780983" cy="424732"/>
          </a:xfrm>
        </p:grpSpPr>
        <p:sp>
          <p:nvSpPr>
            <p:cNvPr id="21" name="Textfeld 20"/>
            <p:cNvSpPr txBox="1"/>
            <p:nvPr/>
          </p:nvSpPr>
          <p:spPr>
            <a:xfrm>
              <a:off x="4324236" y="926627"/>
              <a:ext cx="780983" cy="4247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lang="de-DE" sz="800" dirty="0"/>
                <a:t>M:  Medium</a:t>
              </a:r>
            </a:p>
            <a:p>
              <a:pPr>
                <a:lnSpc>
                  <a:spcPct val="90000"/>
                </a:lnSpc>
              </a:pPr>
              <a:r>
                <a:rPr lang="de-DE" sz="800" dirty="0"/>
                <a:t>P/I: PMA/</a:t>
              </a:r>
            </a:p>
            <a:p>
              <a:pPr>
                <a:lnSpc>
                  <a:spcPct val="90000"/>
                </a:lnSpc>
              </a:pPr>
              <a:r>
                <a:rPr lang="de-DE" sz="500" dirty="0">
                  <a:solidFill>
                    <a:prstClr val="black"/>
                  </a:solidFill>
                </a:rPr>
                <a:t>           </a:t>
              </a:r>
              <a:r>
                <a:rPr lang="de-DE" sz="800" dirty="0" err="1">
                  <a:solidFill>
                    <a:prstClr val="black"/>
                  </a:solidFill>
                </a:rPr>
                <a:t>ionomycin</a:t>
              </a:r>
              <a:endParaRPr lang="de-DE" sz="800" dirty="0">
                <a:solidFill>
                  <a:prstClr val="black"/>
                </a:solidFill>
              </a:endParaRPr>
            </a:p>
          </p:txBody>
        </p:sp>
        <p:sp>
          <p:nvSpPr>
            <p:cNvPr id="22" name="Rechteck 21"/>
            <p:cNvSpPr/>
            <p:nvPr/>
          </p:nvSpPr>
          <p:spPr>
            <a:xfrm>
              <a:off x="4401500" y="968148"/>
              <a:ext cx="629288" cy="33201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30" name="Rechteck 29"/>
          <p:cNvSpPr/>
          <p:nvPr/>
        </p:nvSpPr>
        <p:spPr>
          <a:xfrm>
            <a:off x="1589907" y="402919"/>
            <a:ext cx="603050" cy="35394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700" i="1" dirty="0"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3247082" y="402919"/>
            <a:ext cx="5822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TLA4</a:t>
            </a:r>
          </a:p>
          <a:p>
            <a:pPr algn="ctr"/>
            <a:r>
              <a:rPr lang="de-DE" sz="800" i="1" dirty="0"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036599" y="402919"/>
            <a:ext cx="5725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10</a:t>
            </a:r>
          </a:p>
          <a:p>
            <a:pPr lvl="0" algn="ctr"/>
            <a:r>
              <a:rPr lang="de-DE" sz="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ex vivo)</a:t>
            </a:r>
            <a:endParaRPr lang="en-GB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4097417" y="2615513"/>
            <a:ext cx="4315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IL10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1831470" y="2615513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CTLA4</a:t>
            </a:r>
          </a:p>
        </p:txBody>
      </p:sp>
      <p:sp>
        <p:nvSpPr>
          <p:cNvPr id="10" name="Rechteck 9"/>
          <p:cNvSpPr/>
          <p:nvPr/>
        </p:nvSpPr>
        <p:spPr>
          <a:xfrm>
            <a:off x="137966" y="4937887"/>
            <a:ext cx="7532426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: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rmalization of g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e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to succinate dehydrogenase subunit A (SDHA), a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ference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of a different functional class than beta-2-macroglobulin (B2M), yields comparable results regarding 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of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regulatory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molecules</a:t>
            </a:r>
            <a:r>
              <a:rPr lang="de-DE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in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nin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ventional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non-conventional TCRαβ</a:t>
            </a:r>
            <a:r>
              <a:rPr lang="en-US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cell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population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ompare Fig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)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-C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C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β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 cell subpopulations sorted as shown in Fig. 1A were analyzed for expression of indicate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e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related genes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x vivo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-C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r after 5 h of medium (M) incubation or stimulation with PMA/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onomyci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P/I)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D, E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ingle-positiv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double-positive,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double-negative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ach dot represents one individual dog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zed separately in independent experiments (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4 or 5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D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pending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n normal distribution, data sets are presented with the mean or median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tatistical differences between subpopulations are marked with lines. Additionally, i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D, E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tatistical significance of stimulation-induced effects was calculated for each subpopulation by direct comparison of M versus the P/I equivalent (colored asterisks without lines). (* p &lt; 0.05; ** p &lt; 0.01;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***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&lt;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0.001; ****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 &lt; 0.0001).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1875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01</Words>
  <Application>Microsoft Office PowerPoint</Application>
  <PresentationFormat>Benutzerdefiniert</PresentationFormat>
  <Paragraphs>79</Paragraphs>
  <Slides>4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Keller</dc:creator>
  <cp:lastModifiedBy>Maria Eschke</cp:lastModifiedBy>
  <cp:revision>1088</cp:revision>
  <cp:lastPrinted>2024-02-25T12:03:24Z</cp:lastPrinted>
  <dcterms:created xsi:type="dcterms:W3CDTF">2022-02-08T09:26:11Z</dcterms:created>
  <dcterms:modified xsi:type="dcterms:W3CDTF">2024-04-19T10:59:29Z</dcterms:modified>
</cp:coreProperties>
</file>